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37" autoAdjust="0"/>
    <p:restoredTop sz="94660"/>
  </p:normalViewPr>
  <p:slideViewPr>
    <p:cSldViewPr snapToGrid="0">
      <p:cViewPr varScale="1">
        <p:scale>
          <a:sx n="83" d="100"/>
          <a:sy n="83" d="100"/>
        </p:scale>
        <p:origin x="1075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510A0A-C09F-439C-9C92-ABEDF1FFFE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E832EF-0A69-4CE7-BBAC-8A2FDB2C766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E1E200-FA30-45AA-B12B-67F47A66AB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B9EB0-EC1E-4173-BA78-46882D9DB51A}" type="datetimeFigureOut">
              <a:rPr lang="en-US" smtClean="0"/>
              <a:t>6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61CCC5-CDE9-47DD-B70A-71D984908A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D05FAA-831A-4A94-8CDF-981DDF937E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001A1-92CF-4D99-BEF7-58D0551D0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949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348A3D-0FA7-4380-B411-7B57E35591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8714A1F-CDBE-4B87-B3BB-12F8BD3AF2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54B342-AD7A-4FCD-9DFC-3611CB94D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B9EB0-EC1E-4173-BA78-46882D9DB51A}" type="datetimeFigureOut">
              <a:rPr lang="en-US" smtClean="0"/>
              <a:t>6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52DE16-BF34-4DBE-B19E-F953DF2FB3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480D4F-DB68-4E76-BF93-67176872B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001A1-92CF-4D99-BEF7-58D0551D0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015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8B79876-890B-4A15-B389-49C56679EF4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168D088-9543-4BCE-B431-5A6FD68F1D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474F5B-1F59-487B-BBF4-849B4F017E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B9EB0-EC1E-4173-BA78-46882D9DB51A}" type="datetimeFigureOut">
              <a:rPr lang="en-US" smtClean="0"/>
              <a:t>6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576EE2-D925-48E1-AC34-705BA80F22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04E9E4-6347-4B40-8B80-ACF6FD319A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001A1-92CF-4D99-BEF7-58D0551D0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35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BCBBDD-3D0D-4E9C-BB10-74E3512FC3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60CD2B-54B3-49B3-9E86-CAE3ECC1629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E04E97-4ACC-48F6-8DBC-08BF816958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B9EB0-EC1E-4173-BA78-46882D9DB51A}" type="datetimeFigureOut">
              <a:rPr lang="en-US" smtClean="0"/>
              <a:t>6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4C2944-5A11-47D8-98E1-7639C706D9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958A19-48F5-4CE8-A66F-8B04758302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001A1-92CF-4D99-BEF7-58D0551D0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4130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0F095B-D09D-4E65-9248-6FC9400130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FCE4DF-6ADB-46F2-981A-A5FD16782C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A8C609-A699-4C15-9769-56F143EDCF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B9EB0-EC1E-4173-BA78-46882D9DB51A}" type="datetimeFigureOut">
              <a:rPr lang="en-US" smtClean="0"/>
              <a:t>6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BA683C-3DB0-4724-80D8-E0E9BE4B2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A4431F-2103-4324-AA92-A72D283BA1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001A1-92CF-4D99-BEF7-58D0551D0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782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5BAABE-3AFC-43E9-BA7E-0B2101C5B5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BB3128-1A9B-4846-98F6-B1BB75996D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5AD228-A399-451E-8AF4-E7FB63AC09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E0C217-8697-444B-B62B-FD642134D3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B9EB0-EC1E-4173-BA78-46882D9DB51A}" type="datetimeFigureOut">
              <a:rPr lang="en-US" smtClean="0"/>
              <a:t>6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83EBFF-3A14-4992-AA39-263FC238C4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0190DA-A3B7-4529-814E-9203F1BCC5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001A1-92CF-4D99-BEF7-58D0551D0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790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1EFCEC-8A7C-4470-85F3-7AE1C7E3B1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38E9FB-C782-4775-8265-7FCF61941B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18CD4B-1C42-42D0-8ED4-5CC88EABC8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A2824B8-465A-474B-9C2E-F3FE93E6C06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6CE45CC-36D1-4692-BA60-902E060431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D1DA86F-B84D-4E93-B554-B96B3C5F6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B9EB0-EC1E-4173-BA78-46882D9DB51A}" type="datetimeFigureOut">
              <a:rPr lang="en-US" smtClean="0"/>
              <a:t>6/18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B86E1BC-38DF-4E78-A836-87F9FACE6D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B034116-CCB4-4A8E-B67D-529D680FDC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001A1-92CF-4D99-BEF7-58D0551D0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5568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EB277F-B7A1-4983-B415-4B478CD5AF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D3EAADA-0B4E-42E0-9BBA-86BF2C9AC4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B9EB0-EC1E-4173-BA78-46882D9DB51A}" type="datetimeFigureOut">
              <a:rPr lang="en-US" smtClean="0"/>
              <a:t>6/18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6E0DC7E-2B37-4462-8C2F-65165F4C1C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50FE085-4CBB-4DC9-A0DF-8DFCD8169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001A1-92CF-4D99-BEF7-58D0551D0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5165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01257C9-F37B-4DB1-A0C0-BAAF96898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B9EB0-EC1E-4173-BA78-46882D9DB51A}" type="datetimeFigureOut">
              <a:rPr lang="en-US" smtClean="0"/>
              <a:t>6/18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6358FC5-F73B-49E2-9A06-C45B97F41D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6B713DE-E61A-4D80-9553-C91E13F26A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001A1-92CF-4D99-BEF7-58D0551D0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1829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010734-AC4C-4828-917C-2908F0F578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B1F846-4307-46C2-8714-4A9266E7FC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136762B-5482-4281-BC67-BE3F0EB709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6A4AFE-5913-41B5-A286-4E63E8B23F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B9EB0-EC1E-4173-BA78-46882D9DB51A}" type="datetimeFigureOut">
              <a:rPr lang="en-US" smtClean="0"/>
              <a:t>6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9486F4-0AA7-4425-809D-B7D0986A49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EAAF77-B7E7-4B18-96AA-2D0BADC071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001A1-92CF-4D99-BEF7-58D0551D0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89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A999A6-857D-46EB-924E-252D7988F7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79BB8D2-541D-486E-8DBC-55710430CB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5B0810-93CB-4E76-A9B8-C00210223D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34A443-5DF7-4FB9-8F6B-3DCE8CDD68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B9EB0-EC1E-4173-BA78-46882D9DB51A}" type="datetimeFigureOut">
              <a:rPr lang="en-US" smtClean="0"/>
              <a:t>6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086DF4-1395-45BE-ABDB-127E26386E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5D8AE6-DA96-42E0-812B-943B09B35B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001A1-92CF-4D99-BEF7-58D0551D0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880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E58693D-A5AB-4367-B14A-6F030C434B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CB3755-921F-4C2D-B8C3-7156DC989B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F9D496-7F22-4486-AEF8-3D26FA3AC2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B9EB0-EC1E-4173-BA78-46882D9DB51A}" type="datetimeFigureOut">
              <a:rPr lang="en-US" smtClean="0"/>
              <a:t>6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BB9C8D-49CF-4376-B36D-6F3777322C6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CE5FFC-82D1-4596-AE1A-202818A070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7001A1-92CF-4D99-BEF7-58D0551D0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674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FFBE6E2D-C1B2-4657-AB48-11C97784047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38" b="-4238"/>
          <a:stretch/>
        </p:blipFill>
        <p:spPr bwMode="auto">
          <a:xfrm>
            <a:off x="311498" y="1224000"/>
            <a:ext cx="5167059" cy="49905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>
            <a:extLst>
              <a:ext uri="{FF2B5EF4-FFF2-40B4-BE49-F238E27FC236}">
                <a16:creationId xmlns:a16="http://schemas.microsoft.com/office/drawing/2014/main" id="{1585F37F-776E-4262-BE44-9F92D61125C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39" b="-4239"/>
          <a:stretch/>
        </p:blipFill>
        <p:spPr bwMode="auto">
          <a:xfrm>
            <a:off x="5848140" y="1224000"/>
            <a:ext cx="5167059" cy="49905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6716A91-52D7-4E8B-B45C-E1B099974F8A}"/>
              </a:ext>
            </a:extLst>
          </p:cNvPr>
          <p:cNvSpPr txBox="1"/>
          <p:nvPr/>
        </p:nvSpPr>
        <p:spPr>
          <a:xfrm>
            <a:off x="2646772" y="6183602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</a:t>
            </a:r>
            <a:r>
              <a:rPr lang="en-US" altLang="zh-CN" sz="1400" b="1" dirty="0"/>
              <a:t>a</a:t>
            </a:r>
            <a:r>
              <a:rPr lang="en-US" sz="1400" b="1" dirty="0"/>
              <a:t>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98BAEE0-5811-48F2-B5BD-8A53FB9FF028}"/>
              </a:ext>
            </a:extLst>
          </p:cNvPr>
          <p:cNvSpPr txBox="1"/>
          <p:nvPr/>
        </p:nvSpPr>
        <p:spPr>
          <a:xfrm>
            <a:off x="8431669" y="6158073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b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74957A7-CC26-4D39-914F-215E37EB2DC0}"/>
              </a:ext>
            </a:extLst>
          </p:cNvPr>
          <p:cNvSpPr txBox="1"/>
          <p:nvPr/>
        </p:nvSpPr>
        <p:spPr>
          <a:xfrm>
            <a:off x="2646772" y="1347109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8-38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007C339-442F-40AE-BF4E-E8B6F00763EC}"/>
              </a:ext>
            </a:extLst>
          </p:cNvPr>
          <p:cNvSpPr txBox="1"/>
          <p:nvPr/>
        </p:nvSpPr>
        <p:spPr>
          <a:xfrm>
            <a:off x="1368488" y="4798990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8-37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58F1191-2F77-4C16-B52F-2053BBC860A2}"/>
              </a:ext>
            </a:extLst>
          </p:cNvPr>
          <p:cNvSpPr txBox="1"/>
          <p:nvPr/>
        </p:nvSpPr>
        <p:spPr>
          <a:xfrm>
            <a:off x="2113666" y="4798991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8-37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E50C2DF-61AF-44C5-A462-13379B634F16}"/>
              </a:ext>
            </a:extLst>
          </p:cNvPr>
          <p:cNvSpPr txBox="1"/>
          <p:nvPr/>
        </p:nvSpPr>
        <p:spPr>
          <a:xfrm>
            <a:off x="8198364" y="1362497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8-368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91F6638-196D-4503-80B3-F9399D77F56E}"/>
              </a:ext>
            </a:extLst>
          </p:cNvPr>
          <p:cNvSpPr txBox="1"/>
          <p:nvPr/>
        </p:nvSpPr>
        <p:spPr>
          <a:xfrm>
            <a:off x="7502340" y="4029547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8-367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841554D-E36C-4F1A-951C-ABBD10DAB630}"/>
              </a:ext>
            </a:extLst>
          </p:cNvPr>
          <p:cNvSpPr txBox="1"/>
          <p:nvPr/>
        </p:nvSpPr>
        <p:spPr>
          <a:xfrm>
            <a:off x="7079607" y="4491213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8-366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F1DD186-CB58-46A3-A9EE-89BA81568B25}"/>
              </a:ext>
            </a:extLst>
          </p:cNvPr>
          <p:cNvSpPr txBox="1"/>
          <p:nvPr/>
        </p:nvSpPr>
        <p:spPr>
          <a:xfrm>
            <a:off x="8145214" y="4798989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8-369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723A690-1102-455C-B32C-48DFE39CC86B}"/>
              </a:ext>
            </a:extLst>
          </p:cNvPr>
          <p:cNvSpPr txBox="1"/>
          <p:nvPr/>
        </p:nvSpPr>
        <p:spPr>
          <a:xfrm>
            <a:off x="872482" y="254755"/>
            <a:ext cx="101617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. Mass spectra of frame-shifted calreticulin. A) CRTfs385 B) </a:t>
            </a:r>
            <a:r>
              <a:rPr lang="en-US" sz="1200" dirty="0" err="1"/>
              <a:t>CRTfs</a:t>
            </a:r>
            <a:r>
              <a:rPr lang="en-US" sz="1200" dirty="0"/>
              <a:t> 367. For both fractions extensive C-terminal truncations were observed.</a:t>
            </a:r>
          </a:p>
        </p:txBody>
      </p:sp>
    </p:spTree>
    <p:extLst>
      <p:ext uri="{BB962C8B-B14F-4D97-AF65-F5344CB8AC3E}">
        <p14:creationId xmlns:p14="http://schemas.microsoft.com/office/powerpoint/2010/main" val="6369221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</TotalTime>
  <Words>38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Højrup</dc:creator>
  <cp:lastModifiedBy>MDPI</cp:lastModifiedBy>
  <cp:revision>4</cp:revision>
  <dcterms:created xsi:type="dcterms:W3CDTF">2022-03-31T08:35:21Z</dcterms:created>
  <dcterms:modified xsi:type="dcterms:W3CDTF">2022-06-18T03:20:22Z</dcterms:modified>
</cp:coreProperties>
</file>